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78" r:id="rId2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17" autoAdjust="0"/>
    <p:restoredTop sz="94660"/>
  </p:normalViewPr>
  <p:slideViewPr>
    <p:cSldViewPr snapToGrid="0">
      <p:cViewPr varScale="1">
        <p:scale>
          <a:sx n="76" d="100"/>
          <a:sy n="76" d="100"/>
        </p:scale>
        <p:origin x="2880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F1CF703-F042-42C7-AA8F-96FC6DD36FEF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6788" y="1143000"/>
            <a:ext cx="23844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3ACAD6D-E854-487B-87D2-D9F1FB9951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979376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9BC7B-D6D8-4892-8405-1D025FB6B3C0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2DBA2-F2F9-4F66-B1FD-2F2893104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35123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9BC7B-D6D8-4892-8405-1D025FB6B3C0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2DBA2-F2F9-4F66-B1FD-2F2893104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29491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9BC7B-D6D8-4892-8405-1D025FB6B3C0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2DBA2-F2F9-4F66-B1FD-2F2893104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97949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9BC7B-D6D8-4892-8405-1D025FB6B3C0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2DBA2-F2F9-4F66-B1FD-2F2893104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27210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9BC7B-D6D8-4892-8405-1D025FB6B3C0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2DBA2-F2F9-4F66-B1FD-2F2893104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41906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9BC7B-D6D8-4892-8405-1D025FB6B3C0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2DBA2-F2F9-4F66-B1FD-2F2893104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49621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9BC7B-D6D8-4892-8405-1D025FB6B3C0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2DBA2-F2F9-4F66-B1FD-2F2893104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46693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9BC7B-D6D8-4892-8405-1D025FB6B3C0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2DBA2-F2F9-4F66-B1FD-2F2893104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22846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9BC7B-D6D8-4892-8405-1D025FB6B3C0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2DBA2-F2F9-4F66-B1FD-2F2893104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27863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9BC7B-D6D8-4892-8405-1D025FB6B3C0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2DBA2-F2F9-4F66-B1FD-2F2893104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38158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9BC7B-D6D8-4892-8405-1D025FB6B3C0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2DBA2-F2F9-4F66-B1FD-2F2893104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41164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09BC7B-D6D8-4892-8405-1D025FB6B3C0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E2DBA2-F2F9-4F66-B1FD-2F28931049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56917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B036A900-319E-4224-B616-886E720E85BF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0561" t="11497" b="15981"/>
          <a:stretch/>
        </p:blipFill>
        <p:spPr>
          <a:xfrm>
            <a:off x="687175" y="3760761"/>
            <a:ext cx="3752238" cy="1985217"/>
          </a:xfrm>
          <a:prstGeom prst="rect">
            <a:avLst/>
          </a:prstGeom>
        </p:spPr>
      </p:pic>
      <p:graphicFrame>
        <p:nvGraphicFramePr>
          <p:cNvPr id="7" name="Table 6">
            <a:extLst>
              <a:ext uri="{FF2B5EF4-FFF2-40B4-BE49-F238E27FC236}">
                <a16:creationId xmlns:a16="http://schemas.microsoft.com/office/drawing/2014/main" id="{17B4A3AF-1B9D-49EC-B26F-151E555ECBEE}"/>
              </a:ext>
            </a:extLst>
          </p:cNvPr>
          <p:cNvGraphicFramePr>
            <a:graphicFrameLocks noGrp="1"/>
          </p:cNvGraphicFramePr>
          <p:nvPr/>
        </p:nvGraphicFramePr>
        <p:xfrm>
          <a:off x="683292" y="5756672"/>
          <a:ext cx="2730498" cy="3423919"/>
        </p:xfrm>
        <a:graphic>
          <a:graphicData uri="http://schemas.openxmlformats.org/drawingml/2006/table">
            <a:tbl>
              <a:tblPr/>
              <a:tblGrid>
                <a:gridCol w="201514">
                  <a:extLst>
                    <a:ext uri="{9D8B030D-6E8A-4147-A177-3AD203B41FA5}">
                      <a16:colId xmlns:a16="http://schemas.microsoft.com/office/drawing/2014/main" val="4162387807"/>
                    </a:ext>
                  </a:extLst>
                </a:gridCol>
                <a:gridCol w="352648">
                  <a:extLst>
                    <a:ext uri="{9D8B030D-6E8A-4147-A177-3AD203B41FA5}">
                      <a16:colId xmlns:a16="http://schemas.microsoft.com/office/drawing/2014/main" val="4222639532"/>
                    </a:ext>
                  </a:extLst>
                </a:gridCol>
                <a:gridCol w="272042">
                  <a:extLst>
                    <a:ext uri="{9D8B030D-6E8A-4147-A177-3AD203B41FA5}">
                      <a16:colId xmlns:a16="http://schemas.microsoft.com/office/drawing/2014/main" val="2164443760"/>
                    </a:ext>
                  </a:extLst>
                </a:gridCol>
                <a:gridCol w="272042">
                  <a:extLst>
                    <a:ext uri="{9D8B030D-6E8A-4147-A177-3AD203B41FA5}">
                      <a16:colId xmlns:a16="http://schemas.microsoft.com/office/drawing/2014/main" val="2297168243"/>
                    </a:ext>
                  </a:extLst>
                </a:gridCol>
                <a:gridCol w="272042">
                  <a:extLst>
                    <a:ext uri="{9D8B030D-6E8A-4147-A177-3AD203B41FA5}">
                      <a16:colId xmlns:a16="http://schemas.microsoft.com/office/drawing/2014/main" val="4288738513"/>
                    </a:ext>
                  </a:extLst>
                </a:gridCol>
                <a:gridCol w="272042">
                  <a:extLst>
                    <a:ext uri="{9D8B030D-6E8A-4147-A177-3AD203B41FA5}">
                      <a16:colId xmlns:a16="http://schemas.microsoft.com/office/drawing/2014/main" val="4205967609"/>
                    </a:ext>
                  </a:extLst>
                </a:gridCol>
                <a:gridCol w="272042">
                  <a:extLst>
                    <a:ext uri="{9D8B030D-6E8A-4147-A177-3AD203B41FA5}">
                      <a16:colId xmlns:a16="http://schemas.microsoft.com/office/drawing/2014/main" val="1096114586"/>
                    </a:ext>
                  </a:extLst>
                </a:gridCol>
                <a:gridCol w="272042">
                  <a:extLst>
                    <a:ext uri="{9D8B030D-6E8A-4147-A177-3AD203B41FA5}">
                      <a16:colId xmlns:a16="http://schemas.microsoft.com/office/drawing/2014/main" val="1673767447"/>
                    </a:ext>
                  </a:extLst>
                </a:gridCol>
                <a:gridCol w="272042">
                  <a:extLst>
                    <a:ext uri="{9D8B030D-6E8A-4147-A177-3AD203B41FA5}">
                      <a16:colId xmlns:a16="http://schemas.microsoft.com/office/drawing/2014/main" val="3469716961"/>
                    </a:ext>
                  </a:extLst>
                </a:gridCol>
                <a:gridCol w="272042">
                  <a:extLst>
                    <a:ext uri="{9D8B030D-6E8A-4147-A177-3AD203B41FA5}">
                      <a16:colId xmlns:a16="http://schemas.microsoft.com/office/drawing/2014/main" val="3694981391"/>
                    </a:ext>
                  </a:extLst>
                </a:gridCol>
              </a:tblGrid>
              <a:tr h="201407"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8"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enotype Cluster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6109349"/>
                  </a:ext>
                </a:extLst>
              </a:tr>
              <a:tr h="201407"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46607745"/>
                  </a:ext>
                </a:extLst>
              </a:tr>
              <a:tr h="201407">
                <a:tc rowSpan="15"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 Family</a:t>
                      </a:r>
                    </a:p>
                  </a:txBody>
                  <a:tcPr marL="9525" marR="9525" marT="9525" marB="0" vert="vert27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_A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25561584"/>
                  </a:ext>
                </a:extLst>
              </a:tr>
              <a:tr h="20140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_B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32363927"/>
                  </a:ext>
                </a:extLst>
              </a:tr>
              <a:tr h="20140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_C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62100450"/>
                  </a:ext>
                </a:extLst>
              </a:tr>
              <a:tr h="20140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_D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81848823"/>
                  </a:ext>
                </a:extLst>
              </a:tr>
              <a:tr h="20140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_E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35550829"/>
                  </a:ext>
                </a:extLst>
              </a:tr>
              <a:tr h="20140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_F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34203534"/>
                  </a:ext>
                </a:extLst>
              </a:tr>
              <a:tr h="20140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_G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75363194"/>
                  </a:ext>
                </a:extLst>
              </a:tr>
              <a:tr h="20140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_H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39272847"/>
                  </a:ext>
                </a:extLst>
              </a:tr>
              <a:tr h="20140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_I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47529573"/>
                  </a:ext>
                </a:extLst>
              </a:tr>
              <a:tr h="20140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_J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77663024"/>
                  </a:ext>
                </a:extLst>
              </a:tr>
              <a:tr h="20140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_K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13416848"/>
                  </a:ext>
                </a:extLst>
              </a:tr>
              <a:tr h="20140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_L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8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50591266"/>
                  </a:ext>
                </a:extLst>
              </a:tr>
              <a:tr h="20140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_M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7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47248505"/>
                  </a:ext>
                </a:extLst>
              </a:tr>
              <a:tr h="20140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_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8757250"/>
                  </a:ext>
                </a:extLst>
              </a:tr>
              <a:tr h="20140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_O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60247841"/>
                  </a:ext>
                </a:extLst>
              </a:tr>
            </a:tbl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14AF6919-7E2C-45B8-AFEC-D00E12BDA51D}"/>
              </a:ext>
            </a:extLst>
          </p:cNvPr>
          <p:cNvSpPr txBox="1"/>
          <p:nvPr/>
        </p:nvSpPr>
        <p:spPr>
          <a:xfrm>
            <a:off x="328743" y="226075"/>
            <a:ext cx="6483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798E9A4-EE84-4AAD-A087-287AA8790A61}"/>
              </a:ext>
            </a:extLst>
          </p:cNvPr>
          <p:cNvSpPr txBox="1"/>
          <p:nvPr/>
        </p:nvSpPr>
        <p:spPr>
          <a:xfrm>
            <a:off x="154630" y="3456383"/>
            <a:ext cx="6483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77BD8DA-D1E2-4F10-A909-BA699BFFD1CF}"/>
              </a:ext>
            </a:extLst>
          </p:cNvPr>
          <p:cNvSpPr txBox="1"/>
          <p:nvPr/>
        </p:nvSpPr>
        <p:spPr>
          <a:xfrm>
            <a:off x="264360" y="5760383"/>
            <a:ext cx="6483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E5F2D072-E8EC-4B73-8F28-BF49ADE68EC5}"/>
              </a:ext>
            </a:extLst>
          </p:cNvPr>
          <p:cNvSpPr txBox="1"/>
          <p:nvPr/>
        </p:nvSpPr>
        <p:spPr>
          <a:xfrm>
            <a:off x="4529231" y="220295"/>
            <a:ext cx="6483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grpSp>
        <p:nvGrpSpPr>
          <p:cNvPr id="52" name="Group 51">
            <a:extLst>
              <a:ext uri="{FF2B5EF4-FFF2-40B4-BE49-F238E27FC236}">
                <a16:creationId xmlns:a16="http://schemas.microsoft.com/office/drawing/2014/main" id="{F396C8DF-0251-4F73-9BE8-FB3884F29F89}"/>
              </a:ext>
            </a:extLst>
          </p:cNvPr>
          <p:cNvGrpSpPr/>
          <p:nvPr/>
        </p:nvGrpSpPr>
        <p:grpSpPr>
          <a:xfrm>
            <a:off x="66252" y="410934"/>
            <a:ext cx="3956743" cy="3158379"/>
            <a:chOff x="-228792" y="335934"/>
            <a:chExt cx="4808878" cy="3838575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17415EC1-F985-4AF8-884F-521D48C5943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r="19604"/>
            <a:stretch/>
          </p:blipFill>
          <p:spPr>
            <a:xfrm>
              <a:off x="-228792" y="335934"/>
              <a:ext cx="4732183" cy="3838575"/>
            </a:xfrm>
            <a:prstGeom prst="rect">
              <a:avLst/>
            </a:prstGeom>
          </p:spPr>
        </p:pic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15A56D7F-5D74-432B-B5BB-FC78521346E2}"/>
                </a:ext>
              </a:extLst>
            </p:cNvPr>
            <p:cNvSpPr txBox="1"/>
            <p:nvPr/>
          </p:nvSpPr>
          <p:spPr>
            <a:xfrm>
              <a:off x="579790" y="3938566"/>
              <a:ext cx="440446" cy="2057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S1_A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4D1B9B63-E2FA-4F09-A381-89E04F25DCF1}"/>
                </a:ext>
              </a:extLst>
            </p:cNvPr>
            <p:cNvSpPr txBox="1"/>
            <p:nvPr/>
          </p:nvSpPr>
          <p:spPr>
            <a:xfrm>
              <a:off x="834066" y="3685039"/>
              <a:ext cx="440446" cy="2057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S1_B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4FD15088-5426-43D5-BCC7-0F42ED6DA8BC}"/>
                </a:ext>
              </a:extLst>
            </p:cNvPr>
            <p:cNvSpPr txBox="1"/>
            <p:nvPr/>
          </p:nvSpPr>
          <p:spPr>
            <a:xfrm>
              <a:off x="1088340" y="3431507"/>
              <a:ext cx="440446" cy="2057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S1_C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D9E5A7BC-09F4-4AF9-9696-DF3942C37945}"/>
                </a:ext>
              </a:extLst>
            </p:cNvPr>
            <p:cNvSpPr txBox="1"/>
            <p:nvPr/>
          </p:nvSpPr>
          <p:spPr>
            <a:xfrm>
              <a:off x="1342615" y="3177977"/>
              <a:ext cx="440446" cy="2057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S1_D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9673FD3D-E03D-4071-81E1-0E30BC7F57C4}"/>
                </a:ext>
              </a:extLst>
            </p:cNvPr>
            <p:cNvSpPr txBox="1"/>
            <p:nvPr/>
          </p:nvSpPr>
          <p:spPr>
            <a:xfrm>
              <a:off x="1596889" y="2924446"/>
              <a:ext cx="440446" cy="2057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S1_E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A6541861-3C5B-4D6B-9C25-C39AB4A6D9B9}"/>
                </a:ext>
              </a:extLst>
            </p:cNvPr>
            <p:cNvSpPr txBox="1"/>
            <p:nvPr/>
          </p:nvSpPr>
          <p:spPr>
            <a:xfrm>
              <a:off x="1851164" y="2670914"/>
              <a:ext cx="440446" cy="2057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S1_F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3FE862D3-C58F-4979-B837-FC7AF0306DA1}"/>
                </a:ext>
              </a:extLst>
            </p:cNvPr>
            <p:cNvSpPr txBox="1"/>
            <p:nvPr/>
          </p:nvSpPr>
          <p:spPr>
            <a:xfrm>
              <a:off x="2105440" y="2417385"/>
              <a:ext cx="440446" cy="2057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S1_G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DB1CE127-BF34-406A-A6AC-D0A8E2E788AE}"/>
                </a:ext>
              </a:extLst>
            </p:cNvPr>
            <p:cNvSpPr txBox="1"/>
            <p:nvPr/>
          </p:nvSpPr>
          <p:spPr>
            <a:xfrm>
              <a:off x="2359716" y="2163851"/>
              <a:ext cx="440446" cy="2057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S1_H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20EF7D74-3F05-4EE1-A313-C36E2737C5B6}"/>
                </a:ext>
              </a:extLst>
            </p:cNvPr>
            <p:cNvSpPr txBox="1"/>
            <p:nvPr/>
          </p:nvSpPr>
          <p:spPr>
            <a:xfrm>
              <a:off x="2613990" y="1910320"/>
              <a:ext cx="440446" cy="2057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S1_I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38C0C4FA-6E1D-4731-91AE-7CA5E0CCA6FA}"/>
                </a:ext>
              </a:extLst>
            </p:cNvPr>
            <p:cNvSpPr txBox="1"/>
            <p:nvPr/>
          </p:nvSpPr>
          <p:spPr>
            <a:xfrm>
              <a:off x="2868265" y="1656790"/>
              <a:ext cx="440446" cy="2057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S1_J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7CEB2B2E-09C7-4E4F-993E-82B93905592B}"/>
                </a:ext>
              </a:extLst>
            </p:cNvPr>
            <p:cNvSpPr txBox="1"/>
            <p:nvPr/>
          </p:nvSpPr>
          <p:spPr>
            <a:xfrm>
              <a:off x="3122542" y="1403259"/>
              <a:ext cx="440446" cy="2057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S1_K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3BD0AD8D-3206-47F9-A131-B80DC0E4F096}"/>
                </a:ext>
              </a:extLst>
            </p:cNvPr>
            <p:cNvSpPr txBox="1"/>
            <p:nvPr/>
          </p:nvSpPr>
          <p:spPr>
            <a:xfrm>
              <a:off x="3376815" y="1149728"/>
              <a:ext cx="440446" cy="2057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S1_L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10B41CBC-68A0-4714-B99D-F92591336F0B}"/>
                </a:ext>
              </a:extLst>
            </p:cNvPr>
            <p:cNvSpPr txBox="1"/>
            <p:nvPr/>
          </p:nvSpPr>
          <p:spPr>
            <a:xfrm>
              <a:off x="3631089" y="896198"/>
              <a:ext cx="440446" cy="2057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S1_M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BC730362-A098-4C1D-8D57-30BFB9A642C5}"/>
                </a:ext>
              </a:extLst>
            </p:cNvPr>
            <p:cNvSpPr txBox="1"/>
            <p:nvPr/>
          </p:nvSpPr>
          <p:spPr>
            <a:xfrm>
              <a:off x="3885365" y="642666"/>
              <a:ext cx="440446" cy="2057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S1_N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7E046270-8248-4534-A9C2-85869C485F25}"/>
                </a:ext>
              </a:extLst>
            </p:cNvPr>
            <p:cNvSpPr txBox="1"/>
            <p:nvPr/>
          </p:nvSpPr>
          <p:spPr>
            <a:xfrm>
              <a:off x="4139640" y="389135"/>
              <a:ext cx="440446" cy="2057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S1_O</a:t>
              </a:r>
            </a:p>
          </p:txBody>
        </p:sp>
      </p:grpSp>
      <p:grpSp>
        <p:nvGrpSpPr>
          <p:cNvPr id="51" name="Group 50">
            <a:extLst>
              <a:ext uri="{FF2B5EF4-FFF2-40B4-BE49-F238E27FC236}">
                <a16:creationId xmlns:a16="http://schemas.microsoft.com/office/drawing/2014/main" id="{04AEFF5F-EDE6-49EE-91E8-2AB11690715A}"/>
              </a:ext>
            </a:extLst>
          </p:cNvPr>
          <p:cNvGrpSpPr/>
          <p:nvPr/>
        </p:nvGrpSpPr>
        <p:grpSpPr>
          <a:xfrm>
            <a:off x="4773868" y="335934"/>
            <a:ext cx="2176998" cy="2022976"/>
            <a:chOff x="4675536" y="4167582"/>
            <a:chExt cx="2755253" cy="2560320"/>
          </a:xfrm>
        </p:grpSpPr>
        <p:pic>
          <p:nvPicPr>
            <p:cNvPr id="48" name="Picture 47">
              <a:extLst>
                <a:ext uri="{FF2B5EF4-FFF2-40B4-BE49-F238E27FC236}">
                  <a16:creationId xmlns:a16="http://schemas.microsoft.com/office/drawing/2014/main" id="{6EBB1264-BA2C-4B03-BE6D-F218E0DCC44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r="12916"/>
            <a:stretch/>
          </p:blipFill>
          <p:spPr>
            <a:xfrm>
              <a:off x="4675536" y="4167582"/>
              <a:ext cx="2755253" cy="2560320"/>
            </a:xfrm>
            <a:prstGeom prst="rect">
              <a:avLst/>
            </a:prstGeom>
          </p:spPr>
        </p:pic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82D3582B-B05A-4E7E-9628-963B33C4052C}"/>
                </a:ext>
              </a:extLst>
            </p:cNvPr>
            <p:cNvSpPr txBox="1"/>
            <p:nvPr/>
          </p:nvSpPr>
          <p:spPr>
            <a:xfrm>
              <a:off x="4813508" y="6421235"/>
              <a:ext cx="44044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8DC4543C-BBC7-43D6-84A5-B74E8052AE9C}"/>
                </a:ext>
              </a:extLst>
            </p:cNvPr>
            <p:cNvSpPr txBox="1"/>
            <p:nvPr/>
          </p:nvSpPr>
          <p:spPr>
            <a:xfrm>
              <a:off x="5141710" y="6111864"/>
              <a:ext cx="44044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96CF339E-2700-4402-BE8A-A7C37E5019FC}"/>
                </a:ext>
              </a:extLst>
            </p:cNvPr>
            <p:cNvSpPr txBox="1"/>
            <p:nvPr/>
          </p:nvSpPr>
          <p:spPr>
            <a:xfrm>
              <a:off x="5449814" y="5802491"/>
              <a:ext cx="44044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F1F511CC-8A48-4425-B52A-12F31B99D244}"/>
                </a:ext>
              </a:extLst>
            </p:cNvPr>
            <p:cNvSpPr txBox="1"/>
            <p:nvPr/>
          </p:nvSpPr>
          <p:spPr>
            <a:xfrm>
              <a:off x="5757921" y="5493120"/>
              <a:ext cx="44044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811CD85F-6426-4509-8906-9552E43F08A6}"/>
                </a:ext>
              </a:extLst>
            </p:cNvPr>
            <p:cNvSpPr txBox="1"/>
            <p:nvPr/>
          </p:nvSpPr>
          <p:spPr>
            <a:xfrm>
              <a:off x="6066025" y="5183747"/>
              <a:ext cx="44044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D99A664F-2978-4C2A-B0D5-5FB363B3FA17}"/>
                </a:ext>
              </a:extLst>
            </p:cNvPr>
            <p:cNvSpPr txBox="1"/>
            <p:nvPr/>
          </p:nvSpPr>
          <p:spPr>
            <a:xfrm>
              <a:off x="6374130" y="4874373"/>
              <a:ext cx="44044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940D94A5-6846-41C4-8EC0-6025155CF753}"/>
                </a:ext>
              </a:extLst>
            </p:cNvPr>
            <p:cNvSpPr txBox="1"/>
            <p:nvPr/>
          </p:nvSpPr>
          <p:spPr>
            <a:xfrm>
              <a:off x="6682235" y="4565000"/>
              <a:ext cx="44044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44DDC315-CC9D-4090-BFAF-5E7C2D4A2278}"/>
                </a:ext>
              </a:extLst>
            </p:cNvPr>
            <p:cNvSpPr txBox="1"/>
            <p:nvPr/>
          </p:nvSpPr>
          <p:spPr>
            <a:xfrm>
              <a:off x="6990343" y="4255627"/>
              <a:ext cx="44044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</p:txBody>
        </p:sp>
      </p:grpSp>
      <p:pic>
        <p:nvPicPr>
          <p:cNvPr id="50" name="Picture 49">
            <a:extLst>
              <a:ext uri="{FF2B5EF4-FFF2-40B4-BE49-F238E27FC236}">
                <a16:creationId xmlns:a16="http://schemas.microsoft.com/office/drawing/2014/main" id="{DC3DB571-C92E-4879-84B8-6EB35390ECF8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0963" t="11933" r="6927" b="17605"/>
          <a:stretch/>
        </p:blipFill>
        <p:spPr>
          <a:xfrm>
            <a:off x="5148108" y="2468209"/>
            <a:ext cx="2432358" cy="1689110"/>
          </a:xfrm>
          <a:prstGeom prst="rect">
            <a:avLst/>
          </a:prstGeom>
        </p:spPr>
      </p:pic>
      <p:graphicFrame>
        <p:nvGraphicFramePr>
          <p:cNvPr id="53" name="Table 52">
            <a:extLst>
              <a:ext uri="{FF2B5EF4-FFF2-40B4-BE49-F238E27FC236}">
                <a16:creationId xmlns:a16="http://schemas.microsoft.com/office/drawing/2014/main" id="{09A24DE8-6E80-4370-AFBC-8DD8E1C26595}"/>
              </a:ext>
            </a:extLst>
          </p:cNvPr>
          <p:cNvGraphicFramePr>
            <a:graphicFrameLocks noGrp="1"/>
          </p:cNvGraphicFramePr>
          <p:nvPr/>
        </p:nvGraphicFramePr>
        <p:xfrm>
          <a:off x="4906913" y="4269943"/>
          <a:ext cx="2432360" cy="3317496"/>
        </p:xfrm>
        <a:graphic>
          <a:graphicData uri="http://schemas.openxmlformats.org/drawingml/2006/table">
            <a:tbl>
              <a:tblPr/>
              <a:tblGrid>
                <a:gridCol w="224180">
                  <a:extLst>
                    <a:ext uri="{9D8B030D-6E8A-4147-A177-3AD203B41FA5}">
                      <a16:colId xmlns:a16="http://schemas.microsoft.com/office/drawing/2014/main" val="3472437126"/>
                    </a:ext>
                  </a:extLst>
                </a:gridCol>
                <a:gridCol w="392316">
                  <a:extLst>
                    <a:ext uri="{9D8B030D-6E8A-4147-A177-3AD203B41FA5}">
                      <a16:colId xmlns:a16="http://schemas.microsoft.com/office/drawing/2014/main" val="490869914"/>
                    </a:ext>
                  </a:extLst>
                </a:gridCol>
                <a:gridCol w="302644">
                  <a:extLst>
                    <a:ext uri="{9D8B030D-6E8A-4147-A177-3AD203B41FA5}">
                      <a16:colId xmlns:a16="http://schemas.microsoft.com/office/drawing/2014/main" val="248622249"/>
                    </a:ext>
                  </a:extLst>
                </a:gridCol>
                <a:gridCol w="302644">
                  <a:extLst>
                    <a:ext uri="{9D8B030D-6E8A-4147-A177-3AD203B41FA5}">
                      <a16:colId xmlns:a16="http://schemas.microsoft.com/office/drawing/2014/main" val="2993121492"/>
                    </a:ext>
                  </a:extLst>
                </a:gridCol>
                <a:gridCol w="302644">
                  <a:extLst>
                    <a:ext uri="{9D8B030D-6E8A-4147-A177-3AD203B41FA5}">
                      <a16:colId xmlns:a16="http://schemas.microsoft.com/office/drawing/2014/main" val="579111073"/>
                    </a:ext>
                  </a:extLst>
                </a:gridCol>
                <a:gridCol w="302644">
                  <a:extLst>
                    <a:ext uri="{9D8B030D-6E8A-4147-A177-3AD203B41FA5}">
                      <a16:colId xmlns:a16="http://schemas.microsoft.com/office/drawing/2014/main" val="1151449574"/>
                    </a:ext>
                  </a:extLst>
                </a:gridCol>
                <a:gridCol w="302644">
                  <a:extLst>
                    <a:ext uri="{9D8B030D-6E8A-4147-A177-3AD203B41FA5}">
                      <a16:colId xmlns:a16="http://schemas.microsoft.com/office/drawing/2014/main" val="3897767864"/>
                    </a:ext>
                  </a:extLst>
                </a:gridCol>
                <a:gridCol w="302644">
                  <a:extLst>
                    <a:ext uri="{9D8B030D-6E8A-4147-A177-3AD203B41FA5}">
                      <a16:colId xmlns:a16="http://schemas.microsoft.com/office/drawing/2014/main" val="4205906622"/>
                    </a:ext>
                  </a:extLst>
                </a:gridCol>
              </a:tblGrid>
              <a:tr h="167304"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6"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henotype Cluster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40395540"/>
                  </a:ext>
                </a:extLst>
              </a:tr>
              <a:tr h="196887"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58801616"/>
                  </a:ext>
                </a:extLst>
              </a:tr>
              <a:tr h="196887">
                <a:tc rowSpan="15"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 Family</a:t>
                      </a:r>
                    </a:p>
                  </a:txBody>
                  <a:tcPr marL="9525" marR="9525" marT="9525" marB="0" vert="vert27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_A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03823591"/>
                  </a:ext>
                </a:extLst>
              </a:tr>
              <a:tr h="19688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_B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76660428"/>
                  </a:ext>
                </a:extLst>
              </a:tr>
              <a:tr h="19688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_C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10453610"/>
                  </a:ext>
                </a:extLst>
              </a:tr>
              <a:tr h="19688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_D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90366067"/>
                  </a:ext>
                </a:extLst>
              </a:tr>
              <a:tr h="19688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_E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17256620"/>
                  </a:ext>
                </a:extLst>
              </a:tr>
              <a:tr h="19688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_F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25623279"/>
                  </a:ext>
                </a:extLst>
              </a:tr>
              <a:tr h="19688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_G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94885616"/>
                  </a:ext>
                </a:extLst>
              </a:tr>
              <a:tr h="19688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_H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74171893"/>
                  </a:ext>
                </a:extLst>
              </a:tr>
              <a:tr h="19688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_I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3092377"/>
                  </a:ext>
                </a:extLst>
              </a:tr>
              <a:tr h="19688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_J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92971024"/>
                  </a:ext>
                </a:extLst>
              </a:tr>
              <a:tr h="19688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_K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38928283"/>
                  </a:ext>
                </a:extLst>
              </a:tr>
              <a:tr h="19688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_L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35453632"/>
                  </a:ext>
                </a:extLst>
              </a:tr>
              <a:tr h="19688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_M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99048380"/>
                  </a:ext>
                </a:extLst>
              </a:tr>
              <a:tr h="19688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_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21306681"/>
                  </a:ext>
                </a:extLst>
              </a:tr>
              <a:tr h="19688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_O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30874710"/>
                  </a:ext>
                </a:extLst>
              </a:tr>
            </a:tbl>
          </a:graphicData>
        </a:graphic>
      </p:graphicFrame>
      <p:grpSp>
        <p:nvGrpSpPr>
          <p:cNvPr id="63" name="Group 62">
            <a:extLst>
              <a:ext uri="{FF2B5EF4-FFF2-40B4-BE49-F238E27FC236}">
                <a16:creationId xmlns:a16="http://schemas.microsoft.com/office/drawing/2014/main" id="{32DDF5C9-10DE-4EE5-9AE4-EEF256659FC6}"/>
              </a:ext>
            </a:extLst>
          </p:cNvPr>
          <p:cNvGrpSpPr/>
          <p:nvPr/>
        </p:nvGrpSpPr>
        <p:grpSpPr>
          <a:xfrm>
            <a:off x="5170381" y="7824105"/>
            <a:ext cx="1521135" cy="1442552"/>
            <a:chOff x="5113682" y="7984739"/>
            <a:chExt cx="2001067" cy="1897690"/>
          </a:xfrm>
        </p:grpSpPr>
        <p:pic>
          <p:nvPicPr>
            <p:cNvPr id="49" name="Picture 48">
              <a:extLst>
                <a:ext uri="{FF2B5EF4-FFF2-40B4-BE49-F238E27FC236}">
                  <a16:creationId xmlns:a16="http://schemas.microsoft.com/office/drawing/2014/main" id="{3BEEF5E8-4217-4058-B035-66DB3F38BC8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3134" t="544" r="14605" b="-544"/>
            <a:stretch/>
          </p:blipFill>
          <p:spPr>
            <a:xfrm>
              <a:off x="5126771" y="7984739"/>
              <a:ext cx="1929100" cy="1897690"/>
            </a:xfrm>
            <a:prstGeom prst="rect">
              <a:avLst/>
            </a:prstGeom>
          </p:spPr>
        </p:pic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3DAE5672-E7DC-4B6C-8CD0-8FE50A86C7D5}"/>
                </a:ext>
              </a:extLst>
            </p:cNvPr>
            <p:cNvSpPr txBox="1"/>
            <p:nvPr/>
          </p:nvSpPr>
          <p:spPr>
            <a:xfrm>
              <a:off x="5113682" y="9576780"/>
              <a:ext cx="44044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1CBC225A-0198-447D-817B-7ABA7CDC48F9}"/>
                </a:ext>
              </a:extLst>
            </p:cNvPr>
            <p:cNvSpPr txBox="1"/>
            <p:nvPr/>
          </p:nvSpPr>
          <p:spPr>
            <a:xfrm>
              <a:off x="5441883" y="9267410"/>
              <a:ext cx="44044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3276348D-EF05-4271-AC24-E252CD11A183}"/>
                </a:ext>
              </a:extLst>
            </p:cNvPr>
            <p:cNvSpPr txBox="1"/>
            <p:nvPr/>
          </p:nvSpPr>
          <p:spPr>
            <a:xfrm>
              <a:off x="5749988" y="8958037"/>
              <a:ext cx="44044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E459E100-6D0D-4552-9792-C300ECB2EECA}"/>
                </a:ext>
              </a:extLst>
            </p:cNvPr>
            <p:cNvSpPr txBox="1"/>
            <p:nvPr/>
          </p:nvSpPr>
          <p:spPr>
            <a:xfrm>
              <a:off x="6058093" y="8648664"/>
              <a:ext cx="44044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C3D0FA27-B911-4006-BA48-3B0353AA0592}"/>
                </a:ext>
              </a:extLst>
            </p:cNvPr>
            <p:cNvSpPr txBox="1"/>
            <p:nvPr/>
          </p:nvSpPr>
          <p:spPr>
            <a:xfrm>
              <a:off x="6366198" y="8339291"/>
              <a:ext cx="44044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950A72B1-2F3B-427D-B886-F3E272846ECD}"/>
                </a:ext>
              </a:extLst>
            </p:cNvPr>
            <p:cNvSpPr txBox="1"/>
            <p:nvPr/>
          </p:nvSpPr>
          <p:spPr>
            <a:xfrm>
              <a:off x="6674303" y="8029918"/>
              <a:ext cx="44044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</p:grpSp>
      <p:sp>
        <p:nvSpPr>
          <p:cNvPr id="60" name="TextBox 59">
            <a:extLst>
              <a:ext uri="{FF2B5EF4-FFF2-40B4-BE49-F238E27FC236}">
                <a16:creationId xmlns:a16="http://schemas.microsoft.com/office/drawing/2014/main" id="{CEF5C78D-6A67-48C3-BC1F-64B6B07031DE}"/>
              </a:ext>
            </a:extLst>
          </p:cNvPr>
          <p:cNvSpPr txBox="1"/>
          <p:nvPr/>
        </p:nvSpPr>
        <p:spPr>
          <a:xfrm>
            <a:off x="4580577" y="2500660"/>
            <a:ext cx="6483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670DBC67-66E5-42B9-9CE1-F79F00E276A0}"/>
              </a:ext>
            </a:extLst>
          </p:cNvPr>
          <p:cNvSpPr txBox="1"/>
          <p:nvPr/>
        </p:nvSpPr>
        <p:spPr>
          <a:xfrm>
            <a:off x="4547442" y="4382838"/>
            <a:ext cx="6483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7E4EF073-2B98-4C39-8EF8-DEF0BD6A5968}"/>
              </a:ext>
            </a:extLst>
          </p:cNvPr>
          <p:cNvSpPr txBox="1"/>
          <p:nvPr/>
        </p:nvSpPr>
        <p:spPr>
          <a:xfrm>
            <a:off x="4529231" y="7741364"/>
            <a:ext cx="6483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pic>
        <p:nvPicPr>
          <p:cNvPr id="65" name="Picture 64">
            <a:extLst>
              <a:ext uri="{FF2B5EF4-FFF2-40B4-BE49-F238E27FC236}">
                <a16:creationId xmlns:a16="http://schemas.microsoft.com/office/drawing/2014/main" id="{E01AE1EC-EAD7-4701-B497-CA40BC6E6CFB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80061" t="43499" r="13727" b="40428"/>
          <a:stretch/>
        </p:blipFill>
        <p:spPr>
          <a:xfrm>
            <a:off x="6875650" y="8056710"/>
            <a:ext cx="579222" cy="97734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760471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67</TotalTime>
  <Words>388</Words>
  <Application>Microsoft Office PowerPoint</Application>
  <PresentationFormat>Custom</PresentationFormat>
  <Paragraphs>29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aura Chatham</dc:creator>
  <cp:lastModifiedBy>Laura Chatham</cp:lastModifiedBy>
  <cp:revision>13</cp:revision>
  <dcterms:created xsi:type="dcterms:W3CDTF">2020-10-13T15:34:43Z</dcterms:created>
  <dcterms:modified xsi:type="dcterms:W3CDTF">2020-12-08T18:10:14Z</dcterms:modified>
</cp:coreProperties>
</file>